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9" d="100"/>
          <a:sy n="59" d="100"/>
        </p:scale>
        <p:origin x="1771" y="8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rbisonst\Desktop\PLoS%20Genetics%20Resubmission\Figure%207.%20Mutant%20verific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rbisonst\Desktop\PLoS%20Genetics%20Resubmission\Figure%207.%20Mutant%20verifica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rbisonst\Desktop\PLoS%20Genetics%20Resubmission\Figure%207.%20Mutant%20verification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C8E-4274-A827-D8BC60BFA50F}"/>
              </c:ext>
            </c:extLst>
          </c:dPt>
          <c:errBars>
            <c:errBarType val="both"/>
            <c:errValType val="cust"/>
            <c:noEndCap val="0"/>
            <c:plus>
              <c:numRef>
                <c:extLst>
                  <c:ext xmlns:c15="http://schemas.microsoft.com/office/drawing/2012/chart" uri="{02D57815-91ED-43cb-92C2-25804820EDAC}">
                    <c15:fullRef>
                      <c15:sqref>boutn!$C$3:$G$3</c15:sqref>
                    </c15:fullRef>
                  </c:ext>
                </c:extLst>
                <c:f>boutn!$C$3:$F$3</c:f>
                <c:numCache>
                  <c:formatCode>General</c:formatCode>
                  <c:ptCount val="4"/>
                  <c:pt idx="0">
                    <c:v>0.34070232350000001</c:v>
                  </c:pt>
                  <c:pt idx="1">
                    <c:v>0.61968943389999998</c:v>
                  </c:pt>
                  <c:pt idx="2">
                    <c:v>0.59328968000000004</c:v>
                  </c:pt>
                  <c:pt idx="3">
                    <c:v>0.67066964039999999</c:v>
                  </c:pt>
                </c:numCache>
              </c:numRef>
            </c:plus>
            <c:minus>
              <c:numRef>
                <c:extLst>
                  <c:ext xmlns:c15="http://schemas.microsoft.com/office/drawing/2012/chart" uri="{02D57815-91ED-43cb-92C2-25804820EDAC}">
                    <c15:fullRef>
                      <c15:sqref>boutn!$C$3:$G$3</c15:sqref>
                    </c15:fullRef>
                  </c:ext>
                </c:extLst>
                <c:f>boutn!$C$3:$F$3</c:f>
                <c:numCache>
                  <c:formatCode>General</c:formatCode>
                  <c:ptCount val="4"/>
                  <c:pt idx="0">
                    <c:v>0.34070232350000001</c:v>
                  </c:pt>
                  <c:pt idx="1">
                    <c:v>0.61968943389999998</c:v>
                  </c:pt>
                  <c:pt idx="2">
                    <c:v>0.59328968000000004</c:v>
                  </c:pt>
                  <c:pt idx="3">
                    <c:v>0.6706696403999999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extLst>
                <c:ext xmlns:c15="http://schemas.microsoft.com/office/drawing/2012/chart" uri="{02D57815-91ED-43cb-92C2-25804820EDAC}">
                  <c15:fullRef>
                    <c15:sqref>boutn!$C$1:$G$1</c15:sqref>
                  </c15:fullRef>
                </c:ext>
              </c:extLst>
              <c:f>boutn!$C$1:$F$1</c:f>
              <c:strCache>
                <c:ptCount val="4"/>
                <c:pt idx="0">
                  <c:v>w1118</c:v>
                </c:pt>
                <c:pt idx="1">
                  <c:v>CG33156</c:v>
                </c:pt>
                <c:pt idx="2">
                  <c:v>fz</c:v>
                </c:pt>
                <c:pt idx="3">
                  <c:v>sgg</c:v>
                </c:pt>
              </c:strCache>
            </c:strRef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boutn!$C$2:$G$2</c15:sqref>
                  </c15:fullRef>
                </c:ext>
              </c:extLst>
              <c:f>boutn!$C$2:$F$2</c:f>
              <c:numCache>
                <c:formatCode>General</c:formatCode>
                <c:ptCount val="4"/>
                <c:pt idx="0">
                  <c:v>16.080225988999999</c:v>
                </c:pt>
                <c:pt idx="1">
                  <c:v>15.094927536</c:v>
                </c:pt>
                <c:pt idx="2">
                  <c:v>9.3885245901999994</c:v>
                </c:pt>
                <c:pt idx="3">
                  <c:v>10.1731884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C8E-4274-A827-D8BC60BFA5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08893600"/>
        <c:axId val="563011712"/>
      </c:barChart>
      <c:catAx>
        <c:axId val="608893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3011712"/>
        <c:crosses val="autoZero"/>
        <c:auto val="1"/>
        <c:lblAlgn val="ctr"/>
        <c:lblOffset val="100"/>
        <c:noMultiLvlLbl val="0"/>
      </c:catAx>
      <c:valAx>
        <c:axId val="5630117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88936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77C-4B89-8DAE-3666E4C551B1}"/>
              </c:ext>
            </c:extLst>
          </c:dPt>
          <c:errBars>
            <c:errBarType val="both"/>
            <c:errValType val="cust"/>
            <c:noEndCap val="0"/>
            <c:plus>
              <c:numRef>
                <c:extLst>
                  <c:ext xmlns:c15="http://schemas.microsoft.com/office/drawing/2012/chart" uri="{02D57815-91ED-43cb-92C2-25804820EDAC}">
                    <c15:fullRef>
                      <c15:sqref>avgboutd!$C$3:$G$3</c15:sqref>
                    </c15:fullRef>
                  </c:ext>
                </c:extLst>
                <c:f>avgboutd!$C$3:$F$3</c:f>
                <c:numCache>
                  <c:formatCode>General</c:formatCode>
                  <c:ptCount val="4"/>
                  <c:pt idx="0">
                    <c:v>2.7066265564999998</c:v>
                  </c:pt>
                  <c:pt idx="1">
                    <c:v>5.8743478916000003</c:v>
                  </c:pt>
                  <c:pt idx="2">
                    <c:v>7.5599886752999996</c:v>
                  </c:pt>
                  <c:pt idx="3">
                    <c:v>10.19529223</c:v>
                  </c:pt>
                </c:numCache>
              </c:numRef>
            </c:plus>
            <c:minus>
              <c:numRef>
                <c:extLst>
                  <c:ext xmlns:c15="http://schemas.microsoft.com/office/drawing/2012/chart" uri="{02D57815-91ED-43cb-92C2-25804820EDAC}">
                    <c15:fullRef>
                      <c15:sqref>avgboutd!$C$3:$G$3</c15:sqref>
                    </c15:fullRef>
                  </c:ext>
                </c:extLst>
                <c:f>avgboutd!$C$3:$F$3</c:f>
                <c:numCache>
                  <c:formatCode>General</c:formatCode>
                  <c:ptCount val="4"/>
                  <c:pt idx="0">
                    <c:v>2.7066265564999998</c:v>
                  </c:pt>
                  <c:pt idx="1">
                    <c:v>5.8743478916000003</c:v>
                  </c:pt>
                  <c:pt idx="2">
                    <c:v>7.5599886752999996</c:v>
                  </c:pt>
                  <c:pt idx="3">
                    <c:v>10.1952922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extLst>
                <c:ext xmlns:c15="http://schemas.microsoft.com/office/drawing/2012/chart" uri="{02D57815-91ED-43cb-92C2-25804820EDAC}">
                  <c15:fullRef>
                    <c15:sqref>avgboutd!$C$1:$G$1</c15:sqref>
                  </c15:fullRef>
                </c:ext>
              </c:extLst>
              <c:f>avgboutd!$C$1:$F$1</c:f>
              <c:strCache>
                <c:ptCount val="4"/>
                <c:pt idx="0">
                  <c:v>w1118</c:v>
                </c:pt>
                <c:pt idx="1">
                  <c:v>CG33156</c:v>
                </c:pt>
                <c:pt idx="2">
                  <c:v>fz</c:v>
                </c:pt>
                <c:pt idx="3">
                  <c:v>sgg</c:v>
                </c:pt>
              </c:strCache>
            </c:strRef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avgboutd!$C$2:$G$2</c15:sqref>
                  </c15:fullRef>
                </c:ext>
              </c:extLst>
              <c:f>avgboutd!$C$2:$F$2</c:f>
              <c:numCache>
                <c:formatCode>General</c:formatCode>
                <c:ptCount val="4"/>
                <c:pt idx="0">
                  <c:v>53.763235584999997</c:v>
                </c:pt>
                <c:pt idx="1">
                  <c:v>46.422335058999998</c:v>
                </c:pt>
                <c:pt idx="2">
                  <c:v>59.892580946999999</c:v>
                </c:pt>
                <c:pt idx="3">
                  <c:v>87.975203113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77C-4B89-8DAE-3666E4C551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3702696"/>
        <c:axId val="293703024"/>
      </c:barChart>
      <c:catAx>
        <c:axId val="2937026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3703024"/>
        <c:crosses val="autoZero"/>
        <c:auto val="1"/>
        <c:lblAlgn val="ctr"/>
        <c:lblOffset val="100"/>
        <c:noMultiLvlLbl val="0"/>
      </c:catAx>
      <c:valAx>
        <c:axId val="29370302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37026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402-40E4-95AD-7CCBBC8E762D}"/>
              </c:ext>
            </c:extLst>
          </c:dPt>
          <c:errBars>
            <c:errBarType val="both"/>
            <c:errValType val="cust"/>
            <c:noEndCap val="0"/>
            <c:plus>
              <c:numRef>
                <c:extLst>
                  <c:ext xmlns:c15="http://schemas.microsoft.com/office/drawing/2012/chart" uri="{02D57815-91ED-43cb-92C2-25804820EDAC}">
                    <c15:fullRef>
                      <c15:sqref>wakeact!$C$3:$G$3</c15:sqref>
                    </c15:fullRef>
                  </c:ext>
                </c:extLst>
                <c:f>wakeact!$C$3:$F$3</c:f>
                <c:numCache>
                  <c:formatCode>General</c:formatCode>
                  <c:ptCount val="4"/>
                  <c:pt idx="0">
                    <c:v>2.4539720500000001E-2</c:v>
                  </c:pt>
                  <c:pt idx="1">
                    <c:v>6.5961193700000004E-2</c:v>
                  </c:pt>
                  <c:pt idx="2">
                    <c:v>7.9082535900000001E-2</c:v>
                  </c:pt>
                  <c:pt idx="3">
                    <c:v>7.8877730500000007E-2</c:v>
                  </c:pt>
                </c:numCache>
              </c:numRef>
            </c:plus>
            <c:minus>
              <c:numRef>
                <c:extLst>
                  <c:ext xmlns:c15="http://schemas.microsoft.com/office/drawing/2012/chart" uri="{02D57815-91ED-43cb-92C2-25804820EDAC}">
                    <c15:fullRef>
                      <c15:sqref>wakeact!$C$3:$G$3</c15:sqref>
                    </c15:fullRef>
                  </c:ext>
                </c:extLst>
                <c:f>wakeact!$C$3:$F$3</c:f>
                <c:numCache>
                  <c:formatCode>General</c:formatCode>
                  <c:ptCount val="4"/>
                  <c:pt idx="0">
                    <c:v>2.4539720500000001E-2</c:v>
                  </c:pt>
                  <c:pt idx="1">
                    <c:v>6.5961193700000004E-2</c:v>
                  </c:pt>
                  <c:pt idx="2">
                    <c:v>7.9082535900000001E-2</c:v>
                  </c:pt>
                  <c:pt idx="3">
                    <c:v>7.8877730500000007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extLst>
                <c:ext xmlns:c15="http://schemas.microsoft.com/office/drawing/2012/chart" uri="{02D57815-91ED-43cb-92C2-25804820EDAC}">
                  <c15:fullRef>
                    <c15:sqref>wakeact!$C$1:$G$1</c15:sqref>
                  </c15:fullRef>
                </c:ext>
              </c:extLst>
              <c:f>wakeact!$C$1:$F$1</c:f>
              <c:strCache>
                <c:ptCount val="4"/>
                <c:pt idx="0">
                  <c:v>w1118</c:v>
                </c:pt>
                <c:pt idx="1">
                  <c:v>CG33156</c:v>
                </c:pt>
                <c:pt idx="2">
                  <c:v>fz</c:v>
                </c:pt>
                <c:pt idx="3">
                  <c:v>sgg</c:v>
                </c:pt>
              </c:strCache>
            </c:strRef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wakeact!$C$2:$G$2</c15:sqref>
                  </c15:fullRef>
                </c:ext>
              </c:extLst>
              <c:f>wakeact!$C$2:$F$2</c:f>
              <c:numCache>
                <c:formatCode>General</c:formatCode>
                <c:ptCount val="4"/>
                <c:pt idx="0">
                  <c:v>2.5587091808000002</c:v>
                </c:pt>
                <c:pt idx="1">
                  <c:v>2.4877027173999999</c:v>
                </c:pt>
                <c:pt idx="2">
                  <c:v>2.5470214262000002</c:v>
                </c:pt>
                <c:pt idx="3">
                  <c:v>2.4905291957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402-40E4-95AD-7CCBBC8E76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6871112"/>
        <c:axId val="556871440"/>
      </c:barChart>
      <c:catAx>
        <c:axId val="556871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6871440"/>
        <c:crosses val="autoZero"/>
        <c:auto val="1"/>
        <c:lblAlgn val="ctr"/>
        <c:lblOffset val="100"/>
        <c:noMultiLvlLbl val="0"/>
      </c:catAx>
      <c:valAx>
        <c:axId val="556871440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68711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B29AAC-A167-4A31-B110-509837442DC6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E6157A-C3E7-4A65-9D2E-EB3818E608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0487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88C0B-E21B-4D74-989D-D9738314342E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11E92-BA76-4627-B37B-DCFD9160C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554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88C0B-E21B-4D74-989D-D9738314342E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11E92-BA76-4627-B37B-DCFD9160C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4901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88C0B-E21B-4D74-989D-D9738314342E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11E92-BA76-4627-B37B-DCFD9160C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04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88C0B-E21B-4D74-989D-D9738314342E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11E92-BA76-4627-B37B-DCFD9160C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047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88C0B-E21B-4D74-989D-D9738314342E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11E92-BA76-4627-B37B-DCFD9160C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6084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88C0B-E21B-4D74-989D-D9738314342E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11E92-BA76-4627-B37B-DCFD9160C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33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88C0B-E21B-4D74-989D-D9738314342E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11E92-BA76-4627-B37B-DCFD9160C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2885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88C0B-E21B-4D74-989D-D9738314342E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11E92-BA76-4627-B37B-DCFD9160C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734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88C0B-E21B-4D74-989D-D9738314342E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11E92-BA76-4627-B37B-DCFD9160C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636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88C0B-E21B-4D74-989D-D9738314342E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11E92-BA76-4627-B37B-DCFD9160C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862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88C0B-E21B-4D74-989D-D9738314342E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411E92-BA76-4627-B37B-DCFD9160C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3805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888C0B-E21B-4D74-989D-D9738314342E}" type="datetimeFigureOut">
              <a:rPr lang="en-US" smtClean="0"/>
              <a:t>8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11E92-BA76-4627-B37B-DCFD9160C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3037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Chart 18">
            <a:extLst>
              <a:ext uri="{FF2B5EF4-FFF2-40B4-BE49-F238E27FC236}">
                <a16:creationId xmlns:a16="http://schemas.microsoft.com/office/drawing/2014/main" id="{6C3000BE-7E55-4982-B3EB-442539F7687C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008338343"/>
              </p:ext>
            </p:extLst>
          </p:nvPr>
        </p:nvGraphicFramePr>
        <p:xfrm>
          <a:off x="3794760" y="164592"/>
          <a:ext cx="2976530" cy="21579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id="{58463248-0F55-435E-BD70-2D3268C1B759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208675864"/>
              </p:ext>
            </p:extLst>
          </p:nvPr>
        </p:nvGraphicFramePr>
        <p:xfrm>
          <a:off x="374904" y="164592"/>
          <a:ext cx="2976530" cy="21579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0" y="801253"/>
            <a:ext cx="492443" cy="80406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dirty="0"/>
              <a:t>Day avg. bout</a:t>
            </a:r>
          </a:p>
          <a:p>
            <a:r>
              <a:rPr lang="en-US" sz="1000" dirty="0"/>
              <a:t>Length (min.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91440" y="9144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394364" y="9144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91440" y="228274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157" y="2767816"/>
            <a:ext cx="338554" cy="145167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sz="1000" dirty="0"/>
              <a:t>Waking activity (</a:t>
            </a:r>
            <a:r>
              <a:rPr lang="en-US" sz="1000" dirty="0" err="1"/>
              <a:t>cts</a:t>
            </a:r>
            <a:r>
              <a:rPr lang="en-US" sz="1000" dirty="0"/>
              <a:t>./min.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540744" y="581894"/>
            <a:ext cx="338554" cy="109260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dirty="0"/>
              <a:t>Night bout number</a:t>
            </a:r>
            <a:endParaRPr lang="en-US" sz="1000" baseline="-25000" dirty="0"/>
          </a:p>
        </p:txBody>
      </p:sp>
      <p:sp>
        <p:nvSpPr>
          <p:cNvPr id="2" name="TextBox 1"/>
          <p:cNvSpPr txBox="1"/>
          <p:nvPr/>
        </p:nvSpPr>
        <p:spPr>
          <a:xfrm>
            <a:off x="1543760" y="98969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*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2673663" y="357836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***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5451671" y="801253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****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6071122" y="712698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****</a:t>
            </a:r>
          </a:p>
        </p:txBody>
      </p:sp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7E87696C-C3DB-4AB3-A58B-C32EDA0196AF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146072873"/>
              </p:ext>
            </p:extLst>
          </p:nvPr>
        </p:nvGraphicFramePr>
        <p:xfrm>
          <a:off x="374904" y="2468880"/>
          <a:ext cx="2976530" cy="21579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373313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2</TotalTime>
  <Words>25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HLB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bison, Susan (NIH/NHLBI) [E]</dc:creator>
  <cp:lastModifiedBy>Harbison, Susan (NIH/NHLBI) [E]</cp:lastModifiedBy>
  <cp:revision>44</cp:revision>
  <dcterms:created xsi:type="dcterms:W3CDTF">2016-01-18T16:35:21Z</dcterms:created>
  <dcterms:modified xsi:type="dcterms:W3CDTF">2017-08-26T14:01:56Z</dcterms:modified>
</cp:coreProperties>
</file>